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120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180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178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119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920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35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94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60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890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605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958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38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D6766-E0B3-974C-8666-55F4D33FDD4E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15968-8426-E24C-A04A-D202AFD5E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401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4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3A set 1 STAT3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06438" y="6160472"/>
            <a:ext cx="1946148" cy="1682496"/>
          </a:xfrm>
          <a:prstGeom prst="rect">
            <a:avLst/>
          </a:prstGeom>
        </p:spPr>
      </p:pic>
      <p:pic>
        <p:nvPicPr>
          <p:cNvPr id="4" name="Picture 3" descr="3A set 1 Tub HuR.tif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76129" y="4024359"/>
            <a:ext cx="1946148" cy="143436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85262" y="55811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3A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3" name="Picture 2" descr="3A S3I-201 Expt - pY-STAT3.jpg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99190" y="1227287"/>
            <a:ext cx="1946148" cy="181975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91430" y="1675385"/>
            <a:ext cx="97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Y-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699190" y="1311089"/>
            <a:ext cx="1946148" cy="34383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4640580" y="1366001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127209" y="5069662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HuR</a:t>
            </a:r>
            <a:endParaRPr lang="en-US" sz="1400" dirty="0" smtClean="0">
              <a:latin typeface="Arial"/>
              <a:cs typeface="Arial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662106" y="4397729"/>
            <a:ext cx="1978474" cy="396452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640580" y="451200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31142" y="4497204"/>
            <a:ext cx="939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699191" y="6411692"/>
            <a:ext cx="1946148" cy="40195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4640580" y="6470563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954335" y="6470563"/>
            <a:ext cx="71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127209" y="7455443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HuR</a:t>
            </a:r>
            <a:endParaRPr lang="en-US" sz="1400" dirty="0" smtClean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1142" y="6930600"/>
            <a:ext cx="939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699191" y="7298044"/>
            <a:ext cx="1953395" cy="417254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4640580" y="7378252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2</a:t>
            </a:r>
          </a:p>
        </p:txBody>
      </p:sp>
      <p:sp>
        <p:nvSpPr>
          <p:cNvPr id="31" name="Rectangle 30"/>
          <p:cNvSpPr/>
          <p:nvPr/>
        </p:nvSpPr>
        <p:spPr>
          <a:xfrm>
            <a:off x="2676129" y="4960185"/>
            <a:ext cx="1953395" cy="417254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4640580" y="5040393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2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570812" y="1087543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640580" y="693060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50688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5262" y="558116"/>
            <a:ext cx="864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3F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6" name="Picture 5" descr="3F pY-STAT3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0476" y="970297"/>
            <a:ext cx="2017776" cy="2098548"/>
          </a:xfrm>
          <a:prstGeom prst="rect">
            <a:avLst/>
          </a:prstGeom>
        </p:spPr>
      </p:pic>
      <p:pic>
        <p:nvPicPr>
          <p:cNvPr id="7" name="Picture 6" descr="3F STAT3.tif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6297" y="3750149"/>
            <a:ext cx="2017776" cy="2098548"/>
          </a:xfrm>
          <a:prstGeom prst="rect">
            <a:avLst/>
          </a:prstGeom>
        </p:spPr>
      </p:pic>
      <p:pic>
        <p:nvPicPr>
          <p:cNvPr id="8" name="Picture 7" descr="3F Tubulin.ti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6297" y="6476580"/>
            <a:ext cx="2017776" cy="2098548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912471" y="8154388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HuR</a:t>
            </a:r>
            <a:endParaRPr lang="en-US" sz="1400" dirty="0" smtClean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39597" y="4624139"/>
            <a:ext cx="71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478024" y="4634713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270260" y="7633269"/>
            <a:ext cx="1186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474073" y="768569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470871" y="1875053"/>
            <a:ext cx="97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Y-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3737952" y="1811477"/>
            <a:ext cx="719999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4469566" y="1890442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7" name="Rectangle 26"/>
          <p:cNvSpPr/>
          <p:nvPr/>
        </p:nvSpPr>
        <p:spPr>
          <a:xfrm>
            <a:off x="2456297" y="1811477"/>
            <a:ext cx="719999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712914" y="4535087"/>
            <a:ext cx="710546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2488408" y="4535087"/>
            <a:ext cx="690451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3754074" y="7556976"/>
            <a:ext cx="719999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2472419" y="7556976"/>
            <a:ext cx="719999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2450476" y="8044911"/>
            <a:ext cx="2023597" cy="417254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4474969" y="812511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2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388261" y="693298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27349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0</Words>
  <Application>Microsoft Macintosh PowerPoint</Application>
  <PresentationFormat>Letter Paper (8.5x11 in)</PresentationFormat>
  <Paragraphs>2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Ma</dc:creator>
  <cp:lastModifiedBy>Jennifer Ma</cp:lastModifiedBy>
  <cp:revision>1</cp:revision>
  <dcterms:created xsi:type="dcterms:W3CDTF">2017-02-06T17:01:30Z</dcterms:created>
  <dcterms:modified xsi:type="dcterms:W3CDTF">2017-02-06T17:05:07Z</dcterms:modified>
</cp:coreProperties>
</file>